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9D78E7-690B-49DF-81E9-46B3082FC7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24B5C13-4559-4489-B9D1-15E451139E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0906EF0-B1B9-4E72-9BF9-419343B85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BE42543-1A44-4BC9-AF68-52C388BE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8AFF03-452F-4FD2-A46B-D310B0985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37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6CA076-4063-4315-95E1-30BCE86D0B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0DB6AE4-1517-4262-B387-B74892BC94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C98BA9-4305-43A3-891C-8DB1CB7D1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52B076-AEEA-45C6-AE76-BC5E8F10F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E796329-FBFF-407B-9A0B-6C3301F44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7234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9214B33-00EE-47CC-AAD3-2763D6B779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3576EBA-CB7D-422D-8AFD-72EB292C54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0E627E6-301F-4743-AACC-E9F64F90F6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4333E1-CAC3-47CD-887F-94CE894B9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C8B7883-C3CD-4D13-9097-27F6F420F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6870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1F8D77-E64A-409E-A3E9-DDD12282EA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465121E-922B-456A-8F85-3659212DA1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AA67C7-66EF-4FA0-B1F0-9BCA69399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B53712E-B5AE-4260-934B-0388F494D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DBBC68F-1C93-4941-87CB-BF6B7B69F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7932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2BC7820-55CA-41A2-99C2-FAAACC7D7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2FA3299-137F-4119-B384-2DD651E58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8002F3F-A341-4D6E-87BF-54BFFCC5B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E658D74-C964-48FE-AEC9-BDB6B15D6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BE14E0-E8C9-4039-8447-FE062FDDA1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6944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E040F11-1C57-407D-968F-0A98918EB7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DC899EA-697F-44E6-A12C-AC5B7C34C2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E5269AB-1A4E-45FD-9171-AF3733E4A4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19C588A-3631-4A10-A1C8-96B0755F4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6852F8B-3A8E-45EE-9201-D8605CDDA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175443A-BD90-48D2-8FA1-E87FB2DB6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4648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16A4773-5FD2-42B3-A991-87E83974C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176A0F2-C39A-4685-AD35-366FEAC4D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6551235-0A35-4E95-8A70-3A0BA8E847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56C64D6-03DB-45A9-813B-1F6B627277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397CC36-B302-4BCD-9A45-D787781E25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F985E8C-6C46-42FC-B9E5-43D834E52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34036A33-AA33-411B-A949-CA3896873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5BD1EEF-4AC2-41E9-BD84-2EDE7A420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5685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C25086-1834-46AB-A54D-F73D85BD6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DA223A0-0A44-4182-8ED4-B0B779BE6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5416162-79B0-4A20-ABCB-DBA445800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F7ABF4A-D0E0-4FBF-B64B-5CAC570C5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144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43DF5B6-FD33-4B84-AC93-4B507C0BC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FEAEA95-8914-41A9-9390-F7737CF5D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1FCCA07-3D21-4E36-BAC1-0CF39ADCC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6817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25FD93-5D4D-408D-9544-0AA8D739B9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354A58F-AAB2-4CAC-91CE-7BA503AF91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BB5C506-3FB0-4129-A621-6698664B9A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A6F07EA-B60B-48A4-95E2-298B3FA7D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70AD509-FF7A-4E99-AF15-722061C2D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CF249F3-6005-42E6-BAB5-AAD0DEDBAF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2543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8F1AF0C-0100-41BE-B6BA-720FE50C0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5F63E37-4EA5-4A60-9B65-A220A45BDE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06FA43A-2917-4399-9E78-000AB6DD1B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3E1B1BC-BEF7-40C5-ADF4-3394DEF5D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2CAB66D-C1F9-4CD1-9A25-5850BF6D9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1DFBEB2-6E50-499A-9695-C2409228C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7270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3F4ACE6-3AC4-4F77-A5A2-FFCB31EBD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241E36A-98AB-4AED-9130-9D16BE62F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E8AB592-BF87-478A-80E7-4735BC5E64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3F8C4-B437-4FB5-BA55-BAF5A606D65A}" type="datetimeFigureOut">
              <a:rPr lang="it-IT" smtClean="0"/>
              <a:t>03/05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68A28E-0B89-44CE-B8D4-7723742A05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39E2D85-87D2-4ADE-A0CB-7DD8B4C921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14448-FC5D-4EFE-8522-D6A32B56762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0508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2CEE8799-C44B-4A7B-8E88-18B6163396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2455"/>
          <a:stretch/>
        </p:blipFill>
        <p:spPr>
          <a:xfrm>
            <a:off x="818946" y="1398274"/>
            <a:ext cx="5113868" cy="3383674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18CB7FB-4288-4C1A-A354-A5AB854CA6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6615" y="1323223"/>
            <a:ext cx="5290772" cy="4729823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4EE73776-63A0-48AD-9136-FE13475DB462}"/>
              </a:ext>
            </a:extLst>
          </p:cNvPr>
          <p:cNvSpPr txBox="1"/>
          <p:nvPr/>
        </p:nvSpPr>
        <p:spPr>
          <a:xfrm>
            <a:off x="398195" y="105658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/>
              <a:t>A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3C1C577A-D473-456B-B01E-3FC950D0584A}"/>
              </a:ext>
            </a:extLst>
          </p:cNvPr>
          <p:cNvSpPr txBox="1"/>
          <p:nvPr/>
        </p:nvSpPr>
        <p:spPr>
          <a:xfrm>
            <a:off x="6436536" y="1114028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000" b="1" dirty="0"/>
              <a:t>B</a:t>
            </a:r>
          </a:p>
        </p:txBody>
      </p:sp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B7DE408B-6E1B-4974-A8F6-A506046E0110}"/>
              </a:ext>
            </a:extLst>
          </p:cNvPr>
          <p:cNvCxnSpPr/>
          <p:nvPr/>
        </p:nvCxnSpPr>
        <p:spPr>
          <a:xfrm>
            <a:off x="3047002" y="1752871"/>
            <a:ext cx="0" cy="52011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diritto 9">
            <a:extLst>
              <a:ext uri="{FF2B5EF4-FFF2-40B4-BE49-F238E27FC236}">
                <a16:creationId xmlns:a16="http://schemas.microsoft.com/office/drawing/2014/main" id="{22488B28-58E2-44BF-AF37-50AE315F8D74}"/>
              </a:ext>
            </a:extLst>
          </p:cNvPr>
          <p:cNvCxnSpPr>
            <a:cxnSpLocks/>
          </p:cNvCxnSpPr>
          <p:nvPr/>
        </p:nvCxnSpPr>
        <p:spPr>
          <a:xfrm>
            <a:off x="4906904" y="1752871"/>
            <a:ext cx="0" cy="185735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7E98BC8D-6024-4C1D-B80B-37899229F48F}"/>
              </a:ext>
            </a:extLst>
          </p:cNvPr>
          <p:cNvCxnSpPr>
            <a:cxnSpLocks/>
          </p:cNvCxnSpPr>
          <p:nvPr/>
        </p:nvCxnSpPr>
        <p:spPr>
          <a:xfrm flipH="1">
            <a:off x="3047002" y="1752871"/>
            <a:ext cx="185990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nettore diritto 14">
            <a:extLst>
              <a:ext uri="{FF2B5EF4-FFF2-40B4-BE49-F238E27FC236}">
                <a16:creationId xmlns:a16="http://schemas.microsoft.com/office/drawing/2014/main" id="{54E82FDC-C29B-4E69-A418-D3DCDCB4A5CF}"/>
              </a:ext>
            </a:extLst>
          </p:cNvPr>
          <p:cNvCxnSpPr/>
          <p:nvPr/>
        </p:nvCxnSpPr>
        <p:spPr>
          <a:xfrm>
            <a:off x="8545842" y="1398274"/>
            <a:ext cx="0" cy="52011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diritto 15">
            <a:extLst>
              <a:ext uri="{FF2B5EF4-FFF2-40B4-BE49-F238E27FC236}">
                <a16:creationId xmlns:a16="http://schemas.microsoft.com/office/drawing/2014/main" id="{7709BA2A-5621-4335-89DD-47AD92A08AF3}"/>
              </a:ext>
            </a:extLst>
          </p:cNvPr>
          <p:cNvCxnSpPr>
            <a:cxnSpLocks/>
          </p:cNvCxnSpPr>
          <p:nvPr/>
        </p:nvCxnSpPr>
        <p:spPr>
          <a:xfrm>
            <a:off x="10405744" y="1398274"/>
            <a:ext cx="0" cy="243660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diritto 16">
            <a:extLst>
              <a:ext uri="{FF2B5EF4-FFF2-40B4-BE49-F238E27FC236}">
                <a16:creationId xmlns:a16="http://schemas.microsoft.com/office/drawing/2014/main" id="{4A51A691-C055-4DCE-A876-2698E19A37D8}"/>
              </a:ext>
            </a:extLst>
          </p:cNvPr>
          <p:cNvCxnSpPr>
            <a:cxnSpLocks/>
          </p:cNvCxnSpPr>
          <p:nvPr/>
        </p:nvCxnSpPr>
        <p:spPr>
          <a:xfrm flipH="1">
            <a:off x="8545842" y="1398274"/>
            <a:ext cx="185990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5B661243-ABB7-4AD6-87BB-C74311212AFB}"/>
              </a:ext>
            </a:extLst>
          </p:cNvPr>
          <p:cNvSpPr txBox="1"/>
          <p:nvPr/>
        </p:nvSpPr>
        <p:spPr>
          <a:xfrm>
            <a:off x="3880995" y="139827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B8F40135-BD72-4BFE-8149-D3DDD2E45FBD}"/>
              </a:ext>
            </a:extLst>
          </p:cNvPr>
          <p:cNvSpPr txBox="1"/>
          <p:nvPr/>
        </p:nvSpPr>
        <p:spPr>
          <a:xfrm>
            <a:off x="9325752" y="111402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*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905D647E-B1B7-4CAB-BF21-4CDC08826A5E}"/>
              </a:ext>
            </a:extLst>
          </p:cNvPr>
          <p:cNvSpPr txBox="1"/>
          <p:nvPr/>
        </p:nvSpPr>
        <p:spPr>
          <a:xfrm>
            <a:off x="653235" y="5161578"/>
            <a:ext cx="1131793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ry Figure 1.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) RS4;11 2′F-ANA Scramble (grey bars) and 2′F-ANA-TEX41 (red bars) treated cells growth (expressed as cells/µL) after 72h of silencing. Cells concentrations are shown as mean +/− SD of three technical independent experiments. B) Bar-plot 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howing downregulation of TEX41 levels in RS4;11 cells treated with the 2′F-ANA oligonucleotides designed against lncRNA TEX41 and with 2′F-ANA Scramble for 72 h. The relative expression was determined using the 2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−ΔCt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thod and it is shown as mean +/− SD of two technical independent experiments. </a:t>
            </a:r>
            <a:endParaRPr lang="it-IT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4ABD174A-1ABB-43BB-85A0-218FCA39EA11}"/>
              </a:ext>
            </a:extLst>
          </p:cNvPr>
          <p:cNvSpPr txBox="1"/>
          <p:nvPr/>
        </p:nvSpPr>
        <p:spPr>
          <a:xfrm>
            <a:off x="7929037" y="654461"/>
            <a:ext cx="264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TEX-41 </a:t>
            </a:r>
            <a:r>
              <a:rPr lang="it-IT" b="1" dirty="0" err="1"/>
              <a:t>levels</a:t>
            </a:r>
            <a:r>
              <a:rPr lang="it-IT" b="1" dirty="0"/>
              <a:t> (</a:t>
            </a:r>
            <a:r>
              <a:rPr lang="it-IT" b="1" dirty="0" err="1"/>
              <a:t>real</a:t>
            </a:r>
            <a:r>
              <a:rPr lang="it-IT" b="1" dirty="0"/>
              <a:t> time)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EB6FF717-B592-4B47-AFA0-9905227EB08E}"/>
              </a:ext>
            </a:extLst>
          </p:cNvPr>
          <p:cNvSpPr txBox="1"/>
          <p:nvPr/>
        </p:nvSpPr>
        <p:spPr>
          <a:xfrm>
            <a:off x="2383872" y="666978"/>
            <a:ext cx="2645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RS4;11 </a:t>
            </a:r>
            <a:r>
              <a:rPr lang="it-IT" b="1" dirty="0" err="1"/>
              <a:t>count</a:t>
            </a:r>
            <a:endParaRPr lang="it-IT" b="1" dirty="0"/>
          </a:p>
        </p:txBody>
      </p:sp>
      <p:pic>
        <p:nvPicPr>
          <p:cNvPr id="21" name="Immagine 20">
            <a:extLst>
              <a:ext uri="{FF2B5EF4-FFF2-40B4-BE49-F238E27FC236}">
                <a16:creationId xmlns:a16="http://schemas.microsoft.com/office/drawing/2014/main" id="{1D6CB072-A843-468B-B856-D7A6E0E0BD6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6132" r="87399" b="34306"/>
          <a:stretch/>
        </p:blipFill>
        <p:spPr>
          <a:xfrm>
            <a:off x="6062326" y="2342054"/>
            <a:ext cx="704480" cy="980415"/>
          </a:xfrm>
          <a:prstGeom prst="rect">
            <a:avLst/>
          </a:prstGeom>
          <a:solidFill>
            <a:schemeClr val="bg1"/>
          </a:solidFill>
        </p:spPr>
      </p:pic>
    </p:spTree>
    <p:extLst>
      <p:ext uri="{BB962C8B-B14F-4D97-AF65-F5344CB8AC3E}">
        <p14:creationId xmlns:p14="http://schemas.microsoft.com/office/powerpoint/2010/main" val="42475934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3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ovanni Smaldone</dc:creator>
  <cp:lastModifiedBy>Giovanni Smaldone</cp:lastModifiedBy>
  <cp:revision>5</cp:revision>
  <dcterms:created xsi:type="dcterms:W3CDTF">2021-04-30T13:13:38Z</dcterms:created>
  <dcterms:modified xsi:type="dcterms:W3CDTF">2021-05-03T12:44:46Z</dcterms:modified>
</cp:coreProperties>
</file>